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jpeg" ContentType="image/jpeg"/>
  <Default Extension="xml" ContentType="application/xml"/>
  <Override PartName="/ppt/embeddings/oleObject3.bin" ContentType="application/vnd.openxmlformats-officedocument.oleObject"/>
  <Default Extension="emf" ContentType="image/x-emf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embeddings/oleObject1.bin" ContentType="application/vnd.openxmlformats-officedocument.oleObject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embeddings/oleObject2.bin" ContentType="application/vnd.openxmlformats-officedocument.oleObjec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Default Extension="vml" ContentType="application/vnd.openxmlformats-officedocument.vmlDrawing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6"/>
  </p:notesMasterIdLst>
  <p:sldIdLst>
    <p:sldId id="280" r:id="rId2"/>
    <p:sldId id="277" r:id="rId3"/>
    <p:sldId id="278" r:id="rId4"/>
    <p:sldId id="279" r:id="rId5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0000FF"/>
    <a:srgbClr val="1903BD"/>
  </p:clrMru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2128" y="-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fld id="{CD13F842-1841-445C-9E98-A1A152CAE142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vert="horz" lIns="91438" tIns="45719" rIns="91438" bIns="4571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fld id="{EBA425D1-E6FE-412A-BEFE-860562746D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84917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339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5831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79202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26241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54018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85320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08489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42198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03264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3239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74239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75F38-005E-4A26-94C2-64A1E8A327F5}" type="datetimeFigureOut">
              <a:rPr lang="en-US" smtClean="0"/>
              <a:pPr/>
              <a:t>4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99033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4" Type="http://schemas.openxmlformats.org/officeDocument/2006/relationships/image" Target="../media/image4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4" Type="http://schemas.openxmlformats.org/officeDocument/2006/relationships/image" Target="../media/image6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786349"/>
            <a:ext cx="60960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rmation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real-time RT-PCR of selected genes differentially expressed in trout swim-up fry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venile brain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liver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early nutritional exposure to plant-based diet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represent mean ± standard deviation of four fish, asterisks indicate significant (p &lt; 0.05) differences. The fold change as identified by microarray analysis is outlined in the accompanying table. The genes chosen for the swim-up fry were keratin 13 (K13), Lissencephaly-1 homolog B (pafah1b1b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bp4l) and chymotrypsin B (Ctrb1). The genes chosen for the brain were Glucagon-2 (gcg2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bp4l), somatolactin (SL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ver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vr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holecystokinin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CK-T). The genes chosen for the liver were chymotrypsin B (Ctrb1), keratin 13 (K13) and cytosolic sulfotransferase 3 (ST1S3)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data from microarray experiments for probe expression of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ded in the table below the graph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59988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8181" y="561201"/>
            <a:ext cx="58988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A. Confirmation of selected microarray targets </a:t>
            </a:r>
            <a:r>
              <a:rPr lang="en-US" sz="1200" b="1" dirty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in trout swim-up fry </a:t>
            </a:r>
            <a:r>
              <a:rPr lang="en-US" sz="1200" b="1" dirty="0" smtClean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by real-time PCR</a:t>
            </a:r>
            <a:endParaRPr lang="en-US" sz="1200" b="1" dirty="0">
              <a:latin typeface="Times New Roman" panose="02020603050405020304" pitchFamily="18" charset="0"/>
              <a:ea typeface="ＭＳ Ｐゴシック" pitchFamily="34" charset="-128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98438" y="990600"/>
            <a:ext cx="6583362" cy="5554662"/>
            <a:chOff x="120981" y="990600"/>
            <a:chExt cx="6583362" cy="5554662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47609884"/>
                </p:ext>
              </p:extLst>
            </p:nvPr>
          </p:nvGraphicFramePr>
          <p:xfrm>
            <a:off x="120981" y="1143000"/>
            <a:ext cx="6583362" cy="5402262"/>
          </p:xfrm>
          <a:graphic>
            <a:graphicData uri="http://schemas.openxmlformats.org/presentationml/2006/ole">
              <p:oleObj spid="_x0000_s3124" name="Prism 5" r:id="rId3" imgW="6591300" imgH="5410200" progId="">
                <p:embed/>
              </p:oleObj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304800" y="990600"/>
              <a:ext cx="1295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ea typeface="ＭＳ Ｐゴシック" pitchFamily="34" charset="-128"/>
                  <a:cs typeface="Times New Roman" panose="02020603050405020304" pitchFamily="18" charset="0"/>
                </a:rPr>
                <a:t>RT-qPCR data</a:t>
              </a:r>
              <a:endPara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28600" y="6705600"/>
            <a:ext cx="6324600" cy="1213019"/>
            <a:chOff x="228600" y="6705600"/>
            <a:chExt cx="6324600" cy="1213019"/>
          </a:xfrm>
        </p:grpSpPr>
        <p:pic>
          <p:nvPicPr>
            <p:cNvPr id="3089" name="Picture 1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7662" y="7125553"/>
              <a:ext cx="6205538" cy="7930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228600" y="6705600"/>
              <a:ext cx="1295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ea typeface="ＭＳ Ｐゴシック" pitchFamily="34" charset="-128"/>
                  <a:cs typeface="Times New Roman" panose="02020603050405020304" pitchFamily="18" charset="0"/>
                </a:rPr>
                <a:t>Microarray data</a:t>
              </a:r>
              <a:endPara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15962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81000" y="180201"/>
            <a:ext cx="609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B</a:t>
            </a:r>
            <a:r>
              <a:rPr lang="en-US" sz="1200" b="1" dirty="0" smtClean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. Confirmation of selected microarray targets in brain of juvenile </a:t>
            </a:r>
            <a:r>
              <a:rPr lang="en-US" sz="1200" b="1" dirty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trout </a:t>
            </a:r>
            <a:r>
              <a:rPr lang="en-US" sz="1200" b="1" dirty="0" smtClean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by real-time PCR</a:t>
            </a:r>
            <a:endParaRPr lang="en-US" sz="1200" b="1" dirty="0">
              <a:latin typeface="Times New Roman" panose="02020603050405020304" pitchFamily="18" charset="0"/>
              <a:ea typeface="ＭＳ Ｐゴシック" pitchFamily="34" charset="-128"/>
              <a:cs typeface="Times New Roman" panose="02020603050405020304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533400" y="485001"/>
            <a:ext cx="5200319" cy="6742539"/>
            <a:chOff x="533400" y="485001"/>
            <a:chExt cx="5200319" cy="6742539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61305006"/>
                </p:ext>
              </p:extLst>
            </p:nvPr>
          </p:nvGraphicFramePr>
          <p:xfrm>
            <a:off x="533400" y="685800"/>
            <a:ext cx="5200319" cy="6541740"/>
          </p:xfrm>
          <a:graphic>
            <a:graphicData uri="http://schemas.openxmlformats.org/presentationml/2006/ole">
              <p:oleObj spid="_x0000_s2095" name="Prism 5" r:id="rId3" imgW="6692900" imgH="8420100" progId="">
                <p:embed/>
              </p:oleObj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609600" y="485001"/>
              <a:ext cx="1295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ea typeface="ＭＳ Ｐゴシック" pitchFamily="34" charset="-128"/>
                  <a:cs typeface="Times New Roman" panose="02020603050405020304" pitchFamily="18" charset="0"/>
                </a:rPr>
                <a:t>RT-qPCR data</a:t>
              </a:r>
              <a:endPara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304800" y="7190601"/>
            <a:ext cx="6324600" cy="1381898"/>
            <a:chOff x="304800" y="7190601"/>
            <a:chExt cx="6324600" cy="1381898"/>
          </a:xfrm>
        </p:grpSpPr>
        <p:pic>
          <p:nvPicPr>
            <p:cNvPr id="2061" name="Picture 1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1481" y="7576740"/>
              <a:ext cx="6317919" cy="9957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304800" y="7190601"/>
              <a:ext cx="1295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ea typeface="ＭＳ Ｐゴシック" pitchFamily="34" charset="-128"/>
                  <a:cs typeface="Times New Roman" panose="02020603050405020304" pitchFamily="18" charset="0"/>
                </a:rPr>
                <a:t>Microarray data</a:t>
              </a:r>
              <a:endPara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634216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8600" y="408801"/>
            <a:ext cx="609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C. Confirmation of selected microarray targets in liver of juvenile </a:t>
            </a:r>
            <a:r>
              <a:rPr lang="en-US" sz="1200" b="1" dirty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trout </a:t>
            </a:r>
            <a:r>
              <a:rPr lang="en-US" sz="1200" b="1" dirty="0" smtClean="0"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rPr>
              <a:t>by real-time PCR</a:t>
            </a:r>
            <a:endParaRPr lang="en-US" sz="1200" b="1" dirty="0">
              <a:latin typeface="Times New Roman" panose="02020603050405020304" pitchFamily="18" charset="0"/>
              <a:ea typeface="ＭＳ Ｐゴシック" pitchFamily="34" charset="-128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52400" y="1018401"/>
            <a:ext cx="6553200" cy="5610999"/>
            <a:chOff x="152400" y="1018401"/>
            <a:chExt cx="6553200" cy="5610999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44766941"/>
                </p:ext>
              </p:extLst>
            </p:nvPr>
          </p:nvGraphicFramePr>
          <p:xfrm>
            <a:off x="192088" y="1319212"/>
            <a:ext cx="6513512" cy="5310188"/>
          </p:xfrm>
          <a:graphic>
            <a:graphicData uri="http://schemas.openxmlformats.org/presentationml/2006/ole">
              <p:oleObj spid="_x0000_s1071" name="Prism 5" r:id="rId3" imgW="6515100" imgH="5308600" progId="">
                <p:embed/>
              </p:oleObj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152400" y="1018401"/>
              <a:ext cx="1295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ea typeface="ＭＳ Ｐゴシック" pitchFamily="34" charset="-128"/>
                  <a:cs typeface="Times New Roman" panose="02020603050405020304" pitchFamily="18" charset="0"/>
                </a:rPr>
                <a:t>RT-qPCR data</a:t>
              </a:r>
              <a:endPara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228600" y="6733401"/>
            <a:ext cx="6248400" cy="1115199"/>
            <a:chOff x="228600" y="6504801"/>
            <a:chExt cx="6248400" cy="1115199"/>
          </a:xfrm>
        </p:grpSpPr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4181" y="6906895"/>
              <a:ext cx="6152819" cy="7131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228600" y="6504801"/>
              <a:ext cx="1295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ea typeface="ＭＳ Ｐゴシック" pitchFamily="34" charset="-128"/>
                  <a:cs typeface="Times New Roman" panose="02020603050405020304" pitchFamily="18" charset="0"/>
                </a:rPr>
                <a:t>Microarray data</a:t>
              </a:r>
              <a:endPara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ea typeface="ＭＳ Ｐゴシック" pitchFamily="34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63421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9</TotalTime>
  <Words>270</Words>
  <Application>Microsoft Macintosh PowerPoint</Application>
  <PresentationFormat>On-screen Show (4:3)</PresentationFormat>
  <Paragraphs>11</Paragraphs>
  <Slides>4</Slides>
  <Notes>0</Notes>
  <HiddenSlides>0</HiddenSlides>
  <MMClips>0</MMClips>
  <ScaleCrop>false</ScaleCrop>
  <HeadingPairs>
    <vt:vector size="6" baseType="variant">
      <vt:variant>
        <vt:lpstr>Design Templat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Prism 5</vt:lpstr>
      <vt:lpstr>Slide 1</vt:lpstr>
      <vt:lpstr>Slide 2</vt:lpstr>
      <vt:lpstr>Slide 3</vt:lpstr>
      <vt:lpstr>Slide 4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alasubram</dc:creator>
  <cp:lastModifiedBy>Mukundh</cp:lastModifiedBy>
  <cp:revision>116</cp:revision>
  <cp:lastPrinted>2014-08-04T13:17:26Z</cp:lastPrinted>
  <dcterms:created xsi:type="dcterms:W3CDTF">2016-04-15T17:48:39Z</dcterms:created>
  <dcterms:modified xsi:type="dcterms:W3CDTF">2016-04-15T17:49:26Z</dcterms:modified>
</cp:coreProperties>
</file>